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09"/>
    <p:restoredTop sz="94694"/>
  </p:normalViewPr>
  <p:slideViewPr>
    <p:cSldViewPr snapToGrid="0" snapToObjects="1">
      <p:cViewPr>
        <p:scale>
          <a:sx n="130" d="100"/>
          <a:sy n="130" d="100"/>
        </p:scale>
        <p:origin x="400" y="6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B9C16D-063F-6544-92A6-554CB0DDAF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6FF351-EC18-C34B-BC08-BB651C6BD7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189ECD-377B-CE4B-9B83-F8724DA1C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F906B0-6C13-FE4C-B42E-9FBB7BE42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A510D-8EEB-9744-BCBE-F7D73A9E8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812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2C1ACE-8F9D-8C4B-A5E8-773A01B218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682268-9C4C-8B4F-9B6A-C4F68EC440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FE4403-B218-3F49-B5CA-0EEBEB906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76D30D-BD01-9F4D-9E63-CC188794E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076C2A-22A3-D24B-B2C9-E71F7C1A6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1893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2B80A1-7913-0E4B-9154-106916C3AB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6682B9-7FF0-5E41-9CB3-8FCE7B9EFA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8B7E8E-4D91-7B48-B21C-7BC2BD636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84214E-B751-E64F-8878-B6EA5763B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EE6648-56DF-F748-BFDD-93C207D45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558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DCB9BC-37AF-8546-BBFF-E2382417E6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544586-A74A-D540-9431-C9D1BBCA5E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CE465F-ECDF-C740-9104-EC0E124F0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37B19E-3A12-0B40-A47D-CC5A262367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BB5E9-8BE5-E44D-9E03-5DD231150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710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8F0225-2B65-F041-B75B-1D6B7AFBFE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3EB9E3-2CE9-864F-9CA8-40B00027CF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1E8061-8435-8141-A318-B1D7347B3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DD8AF2-D5A4-584A-A9F1-70438E0225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FB82FD-6B60-634E-8D1B-64D05EEAF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534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539B07-B89D-3541-A184-E212EC0A42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28ACF2-11DB-FC4D-8744-579AE81409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81D54D-43E2-F446-9F2E-7D592FF0AD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CD6911-6CC8-824A-AB4B-F0DAEFF1E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27A467-6F01-6642-A293-39EE93726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97DE22-5B33-A74B-909C-0CDB858682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546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9CC72-9483-AC48-A8E1-B0E1C92CD7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9AF867-9F0F-254D-A5E7-E992D100CC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78695E-F4CC-B14C-93AB-8DA665DC3B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39F3DC5-241F-4246-A39D-F8494389E5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EB476F-C800-304F-82B0-774CFDBB20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751B4D-2541-1444-BA28-1245D302FF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F797158-9BCC-584A-8CEB-4A5520B84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6EFF32D-94EE-654F-B889-56BE8537E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522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865A22-5723-E047-BC7B-8BDF6D1BDB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D3D8FE7-E24B-C545-9968-5F3D7D1C5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D1799F-4EB8-504B-B6C1-63620DDAC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B33D6F-64C1-EA4B-AC14-D19201A41C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7932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28B39C-64D3-2449-8726-882F3EC5D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F6418D-27C4-CF48-901F-66169D311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428303-D9CA-0343-8853-0349CA607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423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CA85CB-B959-2942-9E6B-E23CB9DDAC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494771-BA3F-6646-9277-5FF281E34C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795A69-7D74-8C47-B53D-4DD786D010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F243D4-FCCC-2C47-8E96-5073361CB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D3B0BD-93D7-E045-A60C-EA4B13F43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2136A6-2B81-884E-8A9D-38EB049F7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649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BEC9BA-7525-9945-B043-273EB2ECA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A8758F-6878-5247-81E7-640415B5F2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01828E-1388-3B4C-85C0-D97642A61E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35539D-6504-6342-992A-8A033C731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3F3458-B954-4B43-873E-EC870BA39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C0EB93-F275-0A4E-A5B0-C9FAE14E6A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5527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2E679A-5911-D345-A9FF-713162B57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255913-E03E-CA4D-8199-D6FCEA1B5A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5B93ED-9898-F248-BB37-DA83C8CD7F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60EB46-3194-6F46-AF95-B5A86E1AEDE4}" type="datetimeFigureOut">
              <a:rPr lang="en-US" smtClean="0"/>
              <a:t>4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B9912F-F176-7B4A-A2F6-93E819DB7C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FF20BF-C01B-1348-91C6-5C16FE7154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AE023E-DE85-4447-8DC9-CCB3FE5952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866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480636-FBB5-954C-B929-379B703C2819}"/>
              </a:ext>
            </a:extLst>
          </p:cNvPr>
          <p:cNvSpPr txBox="1"/>
          <p:nvPr/>
        </p:nvSpPr>
        <p:spPr>
          <a:xfrm>
            <a:off x="4824291" y="338501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9D05B1A-F916-F345-9E6C-8CD7C59B2EF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341" t="30849" r="19068" b="50626"/>
          <a:stretch/>
        </p:blipFill>
        <p:spPr>
          <a:xfrm>
            <a:off x="4824291" y="2016767"/>
            <a:ext cx="5478087" cy="45167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76AAF59-AED6-FB45-86C1-338F9DFAAD0E}"/>
              </a:ext>
            </a:extLst>
          </p:cNvPr>
          <p:cNvSpPr txBox="1"/>
          <p:nvPr/>
        </p:nvSpPr>
        <p:spPr>
          <a:xfrm>
            <a:off x="3798304" y="2054838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EXI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623A9CB-BDD9-9242-9089-5C6C56B622BA}"/>
              </a:ext>
            </a:extLst>
          </p:cNvPr>
          <p:cNvSpPr txBox="1"/>
          <p:nvPr/>
        </p:nvSpPr>
        <p:spPr>
          <a:xfrm>
            <a:off x="4080432" y="4366385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XPF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2D34EBE-622C-AD48-AED3-D41F7E2EC958}"/>
              </a:ext>
            </a:extLst>
          </p:cNvPr>
          <p:cNvSpPr txBox="1"/>
          <p:nvPr/>
        </p:nvSpPr>
        <p:spPr>
          <a:xfrm>
            <a:off x="3830882" y="1264346"/>
            <a:ext cx="6718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iRNA:    Control   HEXIM   TOP2</a:t>
            </a:r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  TOP2</a:t>
            </a:r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   XPF     XPG 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9796844-309E-CE4F-945F-C712685CD7D7}"/>
              </a:ext>
            </a:extLst>
          </p:cNvPr>
          <p:cNvSpPr txBox="1"/>
          <p:nvPr/>
        </p:nvSpPr>
        <p:spPr>
          <a:xfrm>
            <a:off x="4050617" y="4901815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XP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109E654-9264-6249-8784-AA4D13BF3171}"/>
              </a:ext>
            </a:extLst>
          </p:cNvPr>
          <p:cNvSpPr txBox="1"/>
          <p:nvPr/>
        </p:nvSpPr>
        <p:spPr>
          <a:xfrm>
            <a:off x="3822024" y="1578370"/>
            <a:ext cx="6503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BET6:     -      +      -      +     -      +     -      +     -      +    -      +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C8D168A-51B6-6A46-905F-2AB9503213C8}"/>
              </a:ext>
            </a:extLst>
          </p:cNvPr>
          <p:cNvSpPr txBox="1"/>
          <p:nvPr/>
        </p:nvSpPr>
        <p:spPr>
          <a:xfrm>
            <a:off x="3798304" y="2791305"/>
            <a:ext cx="925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OP2</a:t>
            </a:r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7B332C3-FCDB-064F-9F77-6C983B28A63D}"/>
              </a:ext>
            </a:extLst>
          </p:cNvPr>
          <p:cNvSpPr txBox="1"/>
          <p:nvPr/>
        </p:nvSpPr>
        <p:spPr>
          <a:xfrm>
            <a:off x="3798304" y="3687929"/>
            <a:ext cx="924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OP2</a:t>
            </a:r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70F59C7-B037-9146-8981-4521354E9C36}"/>
              </a:ext>
            </a:extLst>
          </p:cNvPr>
          <p:cNvSpPr txBox="1"/>
          <p:nvPr/>
        </p:nvSpPr>
        <p:spPr>
          <a:xfrm>
            <a:off x="3748990" y="5981730"/>
            <a:ext cx="1001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EB20FD54-43BE-FC4B-895D-ED953D677D7B}"/>
              </a:ext>
            </a:extLst>
          </p:cNvPr>
          <p:cNvCxnSpPr>
            <a:cxnSpLocks/>
          </p:cNvCxnSpPr>
          <p:nvPr/>
        </p:nvCxnSpPr>
        <p:spPr>
          <a:xfrm>
            <a:off x="4890280" y="1947702"/>
            <a:ext cx="848212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1EED1B5C-E80A-814C-AE53-E3B4A8E27584}"/>
              </a:ext>
            </a:extLst>
          </p:cNvPr>
          <p:cNvCxnSpPr>
            <a:cxnSpLocks/>
          </p:cNvCxnSpPr>
          <p:nvPr/>
        </p:nvCxnSpPr>
        <p:spPr>
          <a:xfrm>
            <a:off x="5850842" y="1947702"/>
            <a:ext cx="85861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BC92D0E0-1A3E-C842-AF63-5DBB091B9257}"/>
              </a:ext>
            </a:extLst>
          </p:cNvPr>
          <p:cNvCxnSpPr>
            <a:cxnSpLocks/>
          </p:cNvCxnSpPr>
          <p:nvPr/>
        </p:nvCxnSpPr>
        <p:spPr>
          <a:xfrm>
            <a:off x="6779768" y="1946438"/>
            <a:ext cx="85861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7E311A5B-2DA8-C344-A81D-90DB07430DB6}"/>
              </a:ext>
            </a:extLst>
          </p:cNvPr>
          <p:cNvCxnSpPr>
            <a:cxnSpLocks/>
          </p:cNvCxnSpPr>
          <p:nvPr/>
        </p:nvCxnSpPr>
        <p:spPr>
          <a:xfrm>
            <a:off x="7709494" y="1946438"/>
            <a:ext cx="85861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ACC80E53-08C7-634F-9E1C-349B9039A0CE}"/>
              </a:ext>
            </a:extLst>
          </p:cNvPr>
          <p:cNvCxnSpPr>
            <a:cxnSpLocks/>
          </p:cNvCxnSpPr>
          <p:nvPr/>
        </p:nvCxnSpPr>
        <p:spPr>
          <a:xfrm>
            <a:off x="8642748" y="1946438"/>
            <a:ext cx="77219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B3BBB09-7FEC-A343-A922-90C63919078C}"/>
              </a:ext>
            </a:extLst>
          </p:cNvPr>
          <p:cNvCxnSpPr>
            <a:cxnSpLocks/>
          </p:cNvCxnSpPr>
          <p:nvPr/>
        </p:nvCxnSpPr>
        <p:spPr>
          <a:xfrm>
            <a:off x="9492474" y="1953337"/>
            <a:ext cx="77219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Picture 24">
            <a:extLst>
              <a:ext uri="{FF2B5EF4-FFF2-40B4-BE49-F238E27FC236}">
                <a16:creationId xmlns:a16="http://schemas.microsoft.com/office/drawing/2014/main" id="{857AADD6-BD09-704E-BD02-A50CC14759C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511" t="19600" r="17588" b="34856"/>
          <a:stretch/>
        </p:blipFill>
        <p:spPr>
          <a:xfrm>
            <a:off x="4824291" y="2537510"/>
            <a:ext cx="5478087" cy="874236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407F428E-A011-EA48-A6C9-C3ECF3A9DBA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357" t="40271" r="18786" b="29702"/>
          <a:stretch/>
        </p:blipFill>
        <p:spPr>
          <a:xfrm>
            <a:off x="4824291" y="3480810"/>
            <a:ext cx="5478087" cy="782781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3371F5C1-2211-A341-AF86-E4AA0FEC89E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536" t="31275" r="20491" b="51206"/>
          <a:stretch/>
        </p:blipFill>
        <p:spPr>
          <a:xfrm>
            <a:off x="4824291" y="4332656"/>
            <a:ext cx="5478087" cy="43679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1A6DA152-132B-9B42-9505-40A46D2424B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857" t="41283" r="22214" b="23225"/>
          <a:stretch/>
        </p:blipFill>
        <p:spPr>
          <a:xfrm>
            <a:off x="4824981" y="4840281"/>
            <a:ext cx="5477397" cy="495814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AA037EFF-9151-F347-B09D-26DBFB730C3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868" t="44587" r="5898" b="26603"/>
          <a:stretch/>
        </p:blipFill>
        <p:spPr>
          <a:xfrm flipV="1">
            <a:off x="4824291" y="5968394"/>
            <a:ext cx="5501148" cy="404886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B9375716-AFBE-5F47-B775-0F2C3ADE1D0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645" t="21144" r="3331" b="64202"/>
          <a:stretch/>
        </p:blipFill>
        <p:spPr>
          <a:xfrm>
            <a:off x="4824291" y="5401745"/>
            <a:ext cx="5478087" cy="492401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21D44AAC-5903-DA40-82B1-FA0AEE3219F7}"/>
              </a:ext>
            </a:extLst>
          </p:cNvPr>
          <p:cNvSpPr txBox="1"/>
          <p:nvPr/>
        </p:nvSpPr>
        <p:spPr>
          <a:xfrm>
            <a:off x="3785315" y="5405296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</p:spTree>
    <p:extLst>
      <p:ext uri="{BB962C8B-B14F-4D97-AF65-F5344CB8AC3E}">
        <p14:creationId xmlns:p14="http://schemas.microsoft.com/office/powerpoint/2010/main" val="10437348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480636-FBB5-954C-B929-379B703C2819}"/>
              </a:ext>
            </a:extLst>
          </p:cNvPr>
          <p:cNvSpPr txBox="1"/>
          <p:nvPr/>
        </p:nvSpPr>
        <p:spPr>
          <a:xfrm>
            <a:off x="3054485" y="340468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81EBF8E-6A02-474C-B9F4-A09F52A476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16849"/>
            <a:ext cx="12192000" cy="50243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58985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C33E208-6161-AD4C-9989-933591AA95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86515"/>
            <a:ext cx="12192000" cy="3884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76880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8DF5397-DE28-5148-B809-B7161D839A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58091"/>
            <a:ext cx="12192000" cy="31418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64037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480636-FBB5-954C-B929-379B703C2819}"/>
              </a:ext>
            </a:extLst>
          </p:cNvPr>
          <p:cNvSpPr txBox="1"/>
          <p:nvPr/>
        </p:nvSpPr>
        <p:spPr>
          <a:xfrm>
            <a:off x="3054485" y="340468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13312AB-AB1E-0045-8EB2-FFEF89514F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25535"/>
            <a:ext cx="12192000" cy="26069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75911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480636-FBB5-954C-B929-379B703C2819}"/>
              </a:ext>
            </a:extLst>
          </p:cNvPr>
          <p:cNvSpPr txBox="1"/>
          <p:nvPr/>
        </p:nvSpPr>
        <p:spPr>
          <a:xfrm>
            <a:off x="3054485" y="340468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DD12617-990D-EF4C-B338-E7320839E6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04383"/>
            <a:ext cx="12192000" cy="40492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22945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480636-FBB5-954C-B929-379B703C2819}"/>
              </a:ext>
            </a:extLst>
          </p:cNvPr>
          <p:cNvSpPr txBox="1"/>
          <p:nvPr/>
        </p:nvSpPr>
        <p:spPr>
          <a:xfrm>
            <a:off x="3054485" y="340468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A2C140B-C44A-8941-8F34-E65DA25E0B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26250"/>
            <a:ext cx="12192000" cy="22054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29902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480636-FBB5-954C-B929-379B703C2819}"/>
              </a:ext>
            </a:extLst>
          </p:cNvPr>
          <p:cNvSpPr txBox="1"/>
          <p:nvPr/>
        </p:nvSpPr>
        <p:spPr>
          <a:xfrm>
            <a:off x="3054485" y="340468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0D3EF05-3395-5444-93EE-8DEBD42C66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V="1">
            <a:off x="0" y="2070487"/>
            <a:ext cx="12192000" cy="2717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40113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480636-FBB5-954C-B929-379B703C2819}"/>
              </a:ext>
            </a:extLst>
          </p:cNvPr>
          <p:cNvSpPr txBox="1"/>
          <p:nvPr/>
        </p:nvSpPr>
        <p:spPr>
          <a:xfrm>
            <a:off x="3054485" y="340468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CB0BEEF-BD65-ED45-90B4-4C16B82009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300" y="1016000"/>
            <a:ext cx="11709400" cy="482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08330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E480636-FBB5-954C-B929-379B703C2819}"/>
              </a:ext>
            </a:extLst>
          </p:cNvPr>
          <p:cNvSpPr txBox="1"/>
          <p:nvPr/>
        </p:nvSpPr>
        <p:spPr>
          <a:xfrm>
            <a:off x="3054485" y="3404681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00340F9-7DD7-7C40-8E6F-0DF62E7903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44386"/>
            <a:ext cx="12192000" cy="57692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4962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34</Words>
  <Application>Microsoft Macintosh PowerPoint</Application>
  <PresentationFormat>Widescreen</PresentationFormat>
  <Paragraphs>9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8</cp:revision>
  <dcterms:created xsi:type="dcterms:W3CDTF">2020-04-09T01:16:54Z</dcterms:created>
  <dcterms:modified xsi:type="dcterms:W3CDTF">2020-04-09T03:24:22Z</dcterms:modified>
</cp:coreProperties>
</file>